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93" r:id="rId2"/>
    <p:sldId id="288" r:id="rId3"/>
    <p:sldId id="283" r:id="rId4"/>
    <p:sldId id="284" r:id="rId5"/>
    <p:sldId id="290" r:id="rId6"/>
    <p:sldId id="285" r:id="rId7"/>
  </p:sldIdLst>
  <p:sldSz cx="11887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3744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1B3042-F6D7-6504-D09A-3303D58FEC9A}" name="Nour Naji" initials="" userId="S::nnaji1@jh.edu::1bca6cbe-6648-499b-835d-d4c1bf651c7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eodoros Karantanos" initials="TK" lastIdx="3" clrIdx="0"/>
  <p:cmAuthor id="2" name="Theodoros Karantanos" initials="TK [2]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000"/>
    <a:srgbClr val="A00000"/>
    <a:srgbClr val="56A0FB"/>
    <a:srgbClr val="3003EF"/>
    <a:srgbClr val="6E5BDF"/>
    <a:srgbClr val="623DFD"/>
    <a:srgbClr val="5A34FC"/>
    <a:srgbClr val="DA8686"/>
    <a:srgbClr val="CD5B5B"/>
    <a:srgbClr val="E19B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40"/>
    <p:restoredTop sz="88968" autoAdjust="0"/>
  </p:normalViewPr>
  <p:slideViewPr>
    <p:cSldViewPr snapToGrid="0">
      <p:cViewPr>
        <p:scale>
          <a:sx n="69" d="100"/>
          <a:sy n="69" d="100"/>
        </p:scale>
        <p:origin x="2192" y="424"/>
      </p:cViewPr>
      <p:guideLst>
        <p:guide orient="horz" pos="2880"/>
        <p:guide pos="374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Relationship Id="rId14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E31-4EFB-BC02-A59C642B9510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E31-4EFB-BC02-A59C642B9510}"/>
              </c:ext>
            </c:extLst>
          </c:dPt>
          <c:cat>
            <c:strRef>
              <c:f>Sheet1!$Q$9:$Q$11</c:f>
              <c:strCache>
                <c:ptCount val="3"/>
                <c:pt idx="0">
                  <c:v>TP53 WT</c:v>
                </c:pt>
                <c:pt idx="1">
                  <c:v>TP53 KO1</c:v>
                </c:pt>
                <c:pt idx="2">
                  <c:v>TP53 KO2</c:v>
                </c:pt>
              </c:strCache>
            </c:strRef>
          </c:cat>
          <c:val>
            <c:numRef>
              <c:f>Sheet1!$R$9:$R$11</c:f>
              <c:numCache>
                <c:formatCode>General</c:formatCode>
                <c:ptCount val="3"/>
                <c:pt idx="0">
                  <c:v>1</c:v>
                </c:pt>
                <c:pt idx="1">
                  <c:v>6.3790481677032025</c:v>
                </c:pt>
                <c:pt idx="2">
                  <c:v>4.92354525911995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31-4EFB-BC02-A59C642B95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85901120"/>
        <c:axId val="1385904448"/>
      </c:barChart>
      <c:catAx>
        <c:axId val="1385901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5904448"/>
        <c:crosses val="autoZero"/>
        <c:auto val="1"/>
        <c:lblAlgn val="ctr"/>
        <c:lblOffset val="100"/>
        <c:noMultiLvlLbl val="0"/>
      </c:catAx>
      <c:valAx>
        <c:axId val="13859044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5901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2800F7-4A25-324E-BD8B-EBCA8D902525}" type="datetimeFigureOut">
              <a:rPr lang="en-US" smtClean="0"/>
              <a:t>2/2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22400" y="1143000"/>
            <a:ext cx="4013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7FCDE7-E5C5-C048-B186-0070BBAB5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154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1496484"/>
            <a:ext cx="10104120" cy="3183467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4802717"/>
            <a:ext cx="8915400" cy="2207683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768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28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486834"/>
            <a:ext cx="2563178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486834"/>
            <a:ext cx="7540943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742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02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2279653"/>
            <a:ext cx="10252710" cy="3803649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6119286"/>
            <a:ext cx="10252710" cy="2000249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/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017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2434167"/>
            <a:ext cx="50520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2434167"/>
            <a:ext cx="50520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4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486836"/>
            <a:ext cx="10252710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2241551"/>
            <a:ext cx="5028842" cy="109854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3340100"/>
            <a:ext cx="502884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2241551"/>
            <a:ext cx="5053608" cy="109854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3340100"/>
            <a:ext cx="505360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27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3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303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09600"/>
            <a:ext cx="3833931" cy="21336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1316569"/>
            <a:ext cx="6017895" cy="6498167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743200"/>
            <a:ext cx="3833931" cy="508211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34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09600"/>
            <a:ext cx="3833931" cy="21336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1316569"/>
            <a:ext cx="6017895" cy="6498167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743200"/>
            <a:ext cx="3833931" cy="508211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26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486836"/>
            <a:ext cx="1025271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2434167"/>
            <a:ext cx="1025271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8475136"/>
            <a:ext cx="26746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43622-4AD6-43D5-8D10-3B668DFF7677}" type="datetimeFigureOut">
              <a:rPr lang="en-US" smtClean="0"/>
              <a:t>2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8475136"/>
            <a:ext cx="401193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8475136"/>
            <a:ext cx="26746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7719A-7C8E-4540-B963-F9CD5C460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90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19.png"/><Relationship Id="rId5" Type="http://schemas.openxmlformats.org/officeDocument/2006/relationships/image" Target="../media/image14.png"/><Relationship Id="rId10" Type="http://schemas.openxmlformats.org/officeDocument/2006/relationships/image" Target="../media/image18.png"/><Relationship Id="rId4" Type="http://schemas.openxmlformats.org/officeDocument/2006/relationships/image" Target="../media/image13.png"/><Relationship Id="rId9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jpg"/><Relationship Id="rId4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microsoft.com/office/2007/relationships/hdphoto" Target="../media/hdphoto2.wdp"/><Relationship Id="rId4" Type="http://schemas.openxmlformats.org/officeDocument/2006/relationships/image" Target="../media/image25.png"/><Relationship Id="rId9" Type="http://schemas.openxmlformats.org/officeDocument/2006/relationships/image" Target="../media/image2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tiff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F13F53-FDFC-4AC8-A819-3D6CCEA47876}"/>
              </a:ext>
            </a:extLst>
          </p:cNvPr>
          <p:cNvSpPr txBox="1"/>
          <p:nvPr/>
        </p:nvSpPr>
        <p:spPr>
          <a:xfrm>
            <a:off x="138953" y="8774668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B655031-2040-4CCC-A374-DAFC62ACB2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2966" y="5838958"/>
            <a:ext cx="1874633" cy="220790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08D9DC6-C9F2-4951-857E-0762C07A6B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97093" y="5730489"/>
            <a:ext cx="1810236" cy="228061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492CBCF-8EF5-42C8-9082-F551FD900504}"/>
              </a:ext>
            </a:extLst>
          </p:cNvPr>
          <p:cNvSpPr txBox="1"/>
          <p:nvPr/>
        </p:nvSpPr>
        <p:spPr>
          <a:xfrm rot="16200000">
            <a:off x="7074075" y="6510101"/>
            <a:ext cx="729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3A53AB-C59A-444E-8B91-2A18D4169200}"/>
              </a:ext>
            </a:extLst>
          </p:cNvPr>
          <p:cNvSpPr txBox="1"/>
          <p:nvPr/>
        </p:nvSpPr>
        <p:spPr>
          <a:xfrm rot="16200000">
            <a:off x="9193805" y="6476625"/>
            <a:ext cx="729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42F3CD-60C6-452A-83E6-08DB481AE5B1}"/>
              </a:ext>
            </a:extLst>
          </p:cNvPr>
          <p:cNvSpPr txBox="1"/>
          <p:nvPr/>
        </p:nvSpPr>
        <p:spPr>
          <a:xfrm rot="18659772">
            <a:off x="7209372" y="8332762"/>
            <a:ext cx="1541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DS/AML without EP blast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11CC86-42EB-4EB7-8A6C-F44A6FA2664E}"/>
              </a:ext>
            </a:extLst>
          </p:cNvPr>
          <p:cNvSpPr txBox="1"/>
          <p:nvPr/>
        </p:nvSpPr>
        <p:spPr>
          <a:xfrm rot="18659772">
            <a:off x="7703819" y="8353777"/>
            <a:ext cx="1541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DS/AML with EP blas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A24432F-A0F5-49D5-8553-66680FED415C}"/>
              </a:ext>
            </a:extLst>
          </p:cNvPr>
          <p:cNvSpPr txBox="1"/>
          <p:nvPr/>
        </p:nvSpPr>
        <p:spPr>
          <a:xfrm rot="18659772">
            <a:off x="8144805" y="8343509"/>
            <a:ext cx="1541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EL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last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3167EB0-72C9-463C-811B-F4E075428A92}"/>
              </a:ext>
            </a:extLst>
          </p:cNvPr>
          <p:cNvSpPr txBox="1"/>
          <p:nvPr/>
        </p:nvSpPr>
        <p:spPr>
          <a:xfrm rot="18659772">
            <a:off x="9346636" y="8270143"/>
            <a:ext cx="1541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DS/AML without EP CD34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9647FEA-4B23-46A5-9321-B25C915B5C15}"/>
              </a:ext>
            </a:extLst>
          </p:cNvPr>
          <p:cNvSpPr txBox="1"/>
          <p:nvPr/>
        </p:nvSpPr>
        <p:spPr>
          <a:xfrm rot="18659772">
            <a:off x="9841083" y="8291158"/>
            <a:ext cx="1541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DS/AML with EP CD34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853E45-F009-4D20-B72A-C211FB7281A2}"/>
              </a:ext>
            </a:extLst>
          </p:cNvPr>
          <p:cNvSpPr txBox="1"/>
          <p:nvPr/>
        </p:nvSpPr>
        <p:spPr>
          <a:xfrm rot="18659772">
            <a:off x="10282069" y="8280890"/>
            <a:ext cx="1541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EL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4+</a:t>
            </a:r>
          </a:p>
        </p:txBody>
      </p:sp>
      <p:pic>
        <p:nvPicPr>
          <p:cNvPr id="43" name="Picture 4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19AC6577-B2DF-40B5-BCED-00665327742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406" b="6533"/>
          <a:stretch/>
        </p:blipFill>
        <p:spPr>
          <a:xfrm>
            <a:off x="253937" y="2720179"/>
            <a:ext cx="2888335" cy="2740143"/>
          </a:xfrm>
          <a:prstGeom prst="rect">
            <a:avLst/>
          </a:prstGeom>
        </p:spPr>
      </p:pic>
      <p:grpSp>
        <p:nvGrpSpPr>
          <p:cNvPr id="44" name="Group 43">
            <a:extLst>
              <a:ext uri="{FF2B5EF4-FFF2-40B4-BE49-F238E27FC236}">
                <a16:creationId xmlns:a16="http://schemas.microsoft.com/office/drawing/2014/main" id="{CD6C18A0-0BF3-459D-AB57-97A3CFD57EF1}"/>
              </a:ext>
            </a:extLst>
          </p:cNvPr>
          <p:cNvGrpSpPr/>
          <p:nvPr/>
        </p:nvGrpSpPr>
        <p:grpSpPr>
          <a:xfrm>
            <a:off x="3796187" y="2686719"/>
            <a:ext cx="2994253" cy="3014515"/>
            <a:chOff x="3397743" y="3316267"/>
            <a:chExt cx="2994253" cy="3014515"/>
          </a:xfrm>
        </p:grpSpPr>
        <p:pic>
          <p:nvPicPr>
            <p:cNvPr id="45" name="Picture 44" descr="A screenshot of a computer screen&#10;&#10;Description automatically generated">
              <a:extLst>
                <a:ext uri="{FF2B5EF4-FFF2-40B4-BE49-F238E27FC236}">
                  <a16:creationId xmlns:a16="http://schemas.microsoft.com/office/drawing/2014/main" id="{EF28D6D2-A265-428D-8232-FC0008AFCD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160" b="6715"/>
            <a:stretch/>
          </p:blipFill>
          <p:spPr>
            <a:xfrm>
              <a:off x="3643904" y="3316267"/>
              <a:ext cx="2748092" cy="2732888"/>
            </a:xfrm>
            <a:prstGeom prst="rect">
              <a:avLst/>
            </a:prstGeom>
          </p:spPr>
        </p:pic>
        <p:sp>
          <p:nvSpPr>
            <p:cNvPr id="46" name="TextBox 1">
              <a:extLst>
                <a:ext uri="{FF2B5EF4-FFF2-40B4-BE49-F238E27FC236}">
                  <a16:creationId xmlns:a16="http://schemas.microsoft.com/office/drawing/2014/main" id="{5243C281-79D5-4755-B113-60B1A904A158}"/>
                </a:ext>
              </a:extLst>
            </p:cNvPr>
            <p:cNvSpPr txBox="1"/>
            <p:nvPr/>
          </p:nvSpPr>
          <p:spPr>
            <a:xfrm rot="16200000">
              <a:off x="3157020" y="4425563"/>
              <a:ext cx="758445" cy="276999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>
                  <a:latin typeface="Arial"/>
                  <a:cs typeface="Arial"/>
                </a:rPr>
                <a:t>SSC-A</a:t>
              </a:r>
            </a:p>
          </p:txBody>
        </p:sp>
        <p:sp>
          <p:nvSpPr>
            <p:cNvPr id="47" name="TextBox 1">
              <a:extLst>
                <a:ext uri="{FF2B5EF4-FFF2-40B4-BE49-F238E27FC236}">
                  <a16:creationId xmlns:a16="http://schemas.microsoft.com/office/drawing/2014/main" id="{4CC2E963-EC8B-4126-905D-C0C02007957B}"/>
                </a:ext>
              </a:extLst>
            </p:cNvPr>
            <p:cNvSpPr txBox="1"/>
            <p:nvPr/>
          </p:nvSpPr>
          <p:spPr>
            <a:xfrm>
              <a:off x="4760833" y="6053783"/>
              <a:ext cx="758445" cy="276999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>
                  <a:latin typeface="Arial"/>
                  <a:cs typeface="Arial"/>
                </a:rPr>
                <a:t>CD34</a:t>
              </a:r>
            </a:p>
          </p:txBody>
        </p:sp>
      </p:grpSp>
      <p:sp>
        <p:nvSpPr>
          <p:cNvPr id="48" name="TextBox 1">
            <a:extLst>
              <a:ext uri="{FF2B5EF4-FFF2-40B4-BE49-F238E27FC236}">
                <a16:creationId xmlns:a16="http://schemas.microsoft.com/office/drawing/2014/main" id="{FE7BC3E7-0F77-4CD7-BD67-E3C3DB82113C}"/>
              </a:ext>
            </a:extLst>
          </p:cNvPr>
          <p:cNvSpPr txBox="1"/>
          <p:nvPr/>
        </p:nvSpPr>
        <p:spPr>
          <a:xfrm>
            <a:off x="1532841" y="5424234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>
                <a:latin typeface="Arial"/>
                <a:cs typeface="Arial"/>
              </a:rPr>
              <a:t>CD235a</a:t>
            </a:r>
          </a:p>
        </p:txBody>
      </p:sp>
      <p:sp>
        <p:nvSpPr>
          <p:cNvPr id="49" name="TextBox 1">
            <a:extLst>
              <a:ext uri="{FF2B5EF4-FFF2-40B4-BE49-F238E27FC236}">
                <a16:creationId xmlns:a16="http://schemas.microsoft.com/office/drawing/2014/main" id="{50AD40B3-B9B4-4E1E-AC33-30868FF97FB0}"/>
              </a:ext>
            </a:extLst>
          </p:cNvPr>
          <p:cNvSpPr txBox="1"/>
          <p:nvPr/>
        </p:nvSpPr>
        <p:spPr>
          <a:xfrm rot="-5400000">
            <a:off x="-120631" y="3902200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>
                <a:latin typeface="Arial"/>
                <a:cs typeface="Arial"/>
              </a:rPr>
              <a:t>CD71</a:t>
            </a:r>
          </a:p>
        </p:txBody>
      </p:sp>
      <p:sp>
        <p:nvSpPr>
          <p:cNvPr id="50" name="Arrow: Left 49">
            <a:extLst>
              <a:ext uri="{FF2B5EF4-FFF2-40B4-BE49-F238E27FC236}">
                <a16:creationId xmlns:a16="http://schemas.microsoft.com/office/drawing/2014/main" id="{9F43DA54-249B-4B90-95E9-4EC3706FB86C}"/>
              </a:ext>
            </a:extLst>
          </p:cNvPr>
          <p:cNvSpPr/>
          <p:nvPr/>
        </p:nvSpPr>
        <p:spPr>
          <a:xfrm>
            <a:off x="3135422" y="4420299"/>
            <a:ext cx="1569673" cy="247772"/>
          </a:xfrm>
          <a:prstGeom prst="lef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Arrow: Left 50">
            <a:extLst>
              <a:ext uri="{FF2B5EF4-FFF2-40B4-BE49-F238E27FC236}">
                <a16:creationId xmlns:a16="http://schemas.microsoft.com/office/drawing/2014/main" id="{DA1056CF-FCD7-412B-A5F5-53DA46B6A22E}"/>
              </a:ext>
            </a:extLst>
          </p:cNvPr>
          <p:cNvSpPr/>
          <p:nvPr/>
        </p:nvSpPr>
        <p:spPr>
          <a:xfrm rot="10800000">
            <a:off x="6781405" y="4491091"/>
            <a:ext cx="1569673" cy="247772"/>
          </a:xfrm>
          <a:prstGeom prst="lef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2" name="Picture 51" descr="A screen shot of a computer screen&#10;&#10;Description automatically generated">
            <a:extLst>
              <a:ext uri="{FF2B5EF4-FFF2-40B4-BE49-F238E27FC236}">
                <a16:creationId xmlns:a16="http://schemas.microsoft.com/office/drawing/2014/main" id="{384CE716-4C8E-40CF-839B-07809A43C0B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0313" b="5779"/>
          <a:stretch/>
        </p:blipFill>
        <p:spPr>
          <a:xfrm>
            <a:off x="8695989" y="2645783"/>
            <a:ext cx="2844712" cy="2799066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BE4C42BC-052E-4006-90CD-76D1DED8A4DF}"/>
              </a:ext>
            </a:extLst>
          </p:cNvPr>
          <p:cNvSpPr txBox="1"/>
          <p:nvPr/>
        </p:nvSpPr>
        <p:spPr>
          <a:xfrm>
            <a:off x="10039175" y="5355876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D7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2B2262F-694B-466C-8C00-0C9FFAA93739}"/>
              </a:ext>
            </a:extLst>
          </p:cNvPr>
          <p:cNvSpPr txBox="1"/>
          <p:nvPr/>
        </p:nvSpPr>
        <p:spPr>
          <a:xfrm rot="16200000">
            <a:off x="8181795" y="3901220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SSC-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C945364-268A-4C12-A0DF-E850C8DEE980}"/>
              </a:ext>
            </a:extLst>
          </p:cNvPr>
          <p:cNvSpPr txBox="1"/>
          <p:nvPr/>
        </p:nvSpPr>
        <p:spPr>
          <a:xfrm>
            <a:off x="9615" y="158801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TextBox 1">
            <a:extLst>
              <a:ext uri="{FF2B5EF4-FFF2-40B4-BE49-F238E27FC236}">
                <a16:creationId xmlns:a16="http://schemas.microsoft.com/office/drawing/2014/main" id="{05EC2E50-66AE-434A-9F09-8A921AA9030D}"/>
              </a:ext>
            </a:extLst>
          </p:cNvPr>
          <p:cNvSpPr txBox="1"/>
          <p:nvPr/>
        </p:nvSpPr>
        <p:spPr>
          <a:xfrm>
            <a:off x="818334" y="8221492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D45</a:t>
            </a:r>
          </a:p>
        </p:txBody>
      </p:sp>
      <p:sp>
        <p:nvSpPr>
          <p:cNvPr id="60" name="TextBox 1">
            <a:extLst>
              <a:ext uri="{FF2B5EF4-FFF2-40B4-BE49-F238E27FC236}">
                <a16:creationId xmlns:a16="http://schemas.microsoft.com/office/drawing/2014/main" id="{DE46EF83-FD8C-4A1F-B19D-E4576D580084}"/>
              </a:ext>
            </a:extLst>
          </p:cNvPr>
          <p:cNvSpPr txBox="1"/>
          <p:nvPr/>
        </p:nvSpPr>
        <p:spPr>
          <a:xfrm>
            <a:off x="4404086" y="8223976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CRL2</a:t>
            </a:r>
          </a:p>
        </p:txBody>
      </p:sp>
      <p:sp>
        <p:nvSpPr>
          <p:cNvPr id="64" name="TextBox 1">
            <a:extLst>
              <a:ext uri="{FF2B5EF4-FFF2-40B4-BE49-F238E27FC236}">
                <a16:creationId xmlns:a16="http://schemas.microsoft.com/office/drawing/2014/main" id="{ED719F31-7CD2-408A-B3AE-52FF356D6B15}"/>
              </a:ext>
            </a:extLst>
          </p:cNvPr>
          <p:cNvSpPr txBox="1"/>
          <p:nvPr/>
        </p:nvSpPr>
        <p:spPr>
          <a:xfrm>
            <a:off x="2687032" y="8216600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D34</a:t>
            </a:r>
          </a:p>
        </p:txBody>
      </p:sp>
      <p:sp>
        <p:nvSpPr>
          <p:cNvPr id="66" name="TextBox 1">
            <a:extLst>
              <a:ext uri="{FF2B5EF4-FFF2-40B4-BE49-F238E27FC236}">
                <a16:creationId xmlns:a16="http://schemas.microsoft.com/office/drawing/2014/main" id="{DAA1FF3F-2871-439C-88DF-54F8C837D97A}"/>
              </a:ext>
            </a:extLst>
          </p:cNvPr>
          <p:cNvSpPr txBox="1"/>
          <p:nvPr/>
        </p:nvSpPr>
        <p:spPr>
          <a:xfrm>
            <a:off x="6284796" y="8216599"/>
            <a:ext cx="7584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D34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DE655F0-AB70-D096-EFAF-DB77F00057EC}"/>
              </a:ext>
            </a:extLst>
          </p:cNvPr>
          <p:cNvGrpSpPr/>
          <p:nvPr/>
        </p:nvGrpSpPr>
        <p:grpSpPr>
          <a:xfrm>
            <a:off x="-32874" y="6250335"/>
            <a:ext cx="7343548" cy="2079913"/>
            <a:chOff x="243605" y="3238614"/>
            <a:chExt cx="10842275" cy="2407773"/>
          </a:xfrm>
        </p:grpSpPr>
        <p:pic>
          <p:nvPicPr>
            <p:cNvPr id="56" name="Picture 55" descr="A screenshot of a computer generated image&#10;&#10;Description automatically generated">
              <a:extLst>
                <a:ext uri="{FF2B5EF4-FFF2-40B4-BE49-F238E27FC236}">
                  <a16:creationId xmlns:a16="http://schemas.microsoft.com/office/drawing/2014/main" id="{F815488D-4EBB-4770-91BF-243B495AB8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499" b="6030"/>
            <a:stretch/>
          </p:blipFill>
          <p:spPr>
            <a:xfrm>
              <a:off x="544220" y="3238614"/>
              <a:ext cx="2614240" cy="2340112"/>
            </a:xfrm>
            <a:prstGeom prst="rect">
              <a:avLst/>
            </a:prstGeom>
          </p:spPr>
        </p:pic>
        <p:sp>
          <p:nvSpPr>
            <p:cNvPr id="58" name="TextBox 1">
              <a:extLst>
                <a:ext uri="{FF2B5EF4-FFF2-40B4-BE49-F238E27FC236}">
                  <a16:creationId xmlns:a16="http://schemas.microsoft.com/office/drawing/2014/main" id="{C95D4206-63D3-4806-9210-EEE2C65BF05F}"/>
                </a:ext>
              </a:extLst>
            </p:cNvPr>
            <p:cNvSpPr txBox="1"/>
            <p:nvPr/>
          </p:nvSpPr>
          <p:spPr>
            <a:xfrm rot="16200000">
              <a:off x="-137202" y="3929242"/>
              <a:ext cx="1170585" cy="408971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/>
                  <a:cs typeface="Arial"/>
                </a:rPr>
                <a:t>SSC-A</a:t>
              </a:r>
            </a:p>
          </p:txBody>
        </p:sp>
        <p:pic>
          <p:nvPicPr>
            <p:cNvPr id="59" name="Picture 2">
              <a:extLst>
                <a:ext uri="{FF2B5EF4-FFF2-40B4-BE49-F238E27FC236}">
                  <a16:creationId xmlns:a16="http://schemas.microsoft.com/office/drawing/2014/main" id="{64638678-7A37-47EB-82CC-66D66A39680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8" b="6845"/>
            <a:stretch/>
          </p:blipFill>
          <p:spPr bwMode="auto">
            <a:xfrm>
              <a:off x="3388837" y="3327471"/>
              <a:ext cx="2339949" cy="22998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1" name="TextBox 1">
              <a:extLst>
                <a:ext uri="{FF2B5EF4-FFF2-40B4-BE49-F238E27FC236}">
                  <a16:creationId xmlns:a16="http://schemas.microsoft.com/office/drawing/2014/main" id="{4357CAF7-5333-4186-853D-13BF5B0A953D}"/>
                </a:ext>
              </a:extLst>
            </p:cNvPr>
            <p:cNvSpPr txBox="1"/>
            <p:nvPr/>
          </p:nvSpPr>
          <p:spPr>
            <a:xfrm rot="16200000">
              <a:off x="2880063" y="4178517"/>
              <a:ext cx="758445" cy="276998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/>
                  <a:cs typeface="Arial"/>
                </a:rPr>
                <a:t>CD71</a:t>
              </a:r>
            </a:p>
          </p:txBody>
        </p:sp>
        <p:pic>
          <p:nvPicPr>
            <p:cNvPr id="62" name="Picture 4">
              <a:extLst>
                <a:ext uri="{FF2B5EF4-FFF2-40B4-BE49-F238E27FC236}">
                  <a16:creationId xmlns:a16="http://schemas.microsoft.com/office/drawing/2014/main" id="{AC956881-1FE9-4B26-90A3-226F920357E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67" b="5553"/>
            <a:stretch/>
          </p:blipFill>
          <p:spPr bwMode="auto">
            <a:xfrm>
              <a:off x="6019960" y="3348687"/>
              <a:ext cx="2306665" cy="2252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3" name="Picture 5">
              <a:extLst>
                <a:ext uri="{FF2B5EF4-FFF2-40B4-BE49-F238E27FC236}">
                  <a16:creationId xmlns:a16="http://schemas.microsoft.com/office/drawing/2014/main" id="{B1F0DB28-846B-4D60-B290-0948C8153BC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85" b="5466"/>
            <a:stretch/>
          </p:blipFill>
          <p:spPr bwMode="auto">
            <a:xfrm>
              <a:off x="8629081" y="3322245"/>
              <a:ext cx="2456799" cy="23241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5" name="TextBox 1">
              <a:extLst>
                <a:ext uri="{FF2B5EF4-FFF2-40B4-BE49-F238E27FC236}">
                  <a16:creationId xmlns:a16="http://schemas.microsoft.com/office/drawing/2014/main" id="{B2D24C6C-D9E7-4FBA-B0E0-4E4F835C209A}"/>
                </a:ext>
              </a:extLst>
            </p:cNvPr>
            <p:cNvSpPr txBox="1"/>
            <p:nvPr/>
          </p:nvSpPr>
          <p:spPr>
            <a:xfrm rot="16200000">
              <a:off x="5474371" y="4112530"/>
              <a:ext cx="894578" cy="408971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/>
                  <a:cs typeface="Arial"/>
                </a:rPr>
                <a:t>SSC-A</a:t>
              </a:r>
            </a:p>
          </p:txBody>
        </p:sp>
        <p:sp>
          <p:nvSpPr>
            <p:cNvPr id="67" name="TextBox 1">
              <a:extLst>
                <a:ext uri="{FF2B5EF4-FFF2-40B4-BE49-F238E27FC236}">
                  <a16:creationId xmlns:a16="http://schemas.microsoft.com/office/drawing/2014/main" id="{5D121037-B1FF-47FE-8AB5-625FD6A3E2A1}"/>
                </a:ext>
              </a:extLst>
            </p:cNvPr>
            <p:cNvSpPr txBox="1"/>
            <p:nvPr/>
          </p:nvSpPr>
          <p:spPr>
            <a:xfrm rot="16200000">
              <a:off x="8133877" y="4178517"/>
              <a:ext cx="758445" cy="276998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/>
                  <a:cs typeface="Arial"/>
                </a:rPr>
                <a:t>CD71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DB47A040-9F3B-49D5-92EA-4518B7D6CAC0}"/>
              </a:ext>
            </a:extLst>
          </p:cNvPr>
          <p:cNvSpPr txBox="1"/>
          <p:nvPr/>
        </p:nvSpPr>
        <p:spPr>
          <a:xfrm>
            <a:off x="30330" y="2508401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7311365-BBF6-45FA-8EF5-BD10392CD4E3}"/>
              </a:ext>
            </a:extLst>
          </p:cNvPr>
          <p:cNvSpPr txBox="1"/>
          <p:nvPr/>
        </p:nvSpPr>
        <p:spPr>
          <a:xfrm>
            <a:off x="40585" y="5838958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C3BD579-257F-4172-BE44-DF4A5AAF5C1B}"/>
              </a:ext>
            </a:extLst>
          </p:cNvPr>
          <p:cNvSpPr txBox="1"/>
          <p:nvPr/>
        </p:nvSpPr>
        <p:spPr>
          <a:xfrm>
            <a:off x="7106064" y="5698699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F6EC866-6952-D1E5-903F-6240585ED84B}"/>
              </a:ext>
            </a:extLst>
          </p:cNvPr>
          <p:cNvSpPr txBox="1"/>
          <p:nvPr/>
        </p:nvSpPr>
        <p:spPr>
          <a:xfrm>
            <a:off x="9304466" y="5657548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BA8D604-32EB-0755-E2F8-960B8B10643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62536" y="214741"/>
            <a:ext cx="8968261" cy="2280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052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8BE604-D492-4767-BDD8-84EB13DA7509}"/>
              </a:ext>
            </a:extLst>
          </p:cNvPr>
          <p:cNvSpPr txBox="1"/>
          <p:nvPr/>
        </p:nvSpPr>
        <p:spPr>
          <a:xfrm>
            <a:off x="138953" y="8774668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2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76C1688-83F6-470F-9B48-85443141AE13}"/>
              </a:ext>
            </a:extLst>
          </p:cNvPr>
          <p:cNvGrpSpPr/>
          <p:nvPr/>
        </p:nvGrpSpPr>
        <p:grpSpPr>
          <a:xfrm>
            <a:off x="4975730" y="2922310"/>
            <a:ext cx="2959995" cy="1870591"/>
            <a:chOff x="136358" y="287002"/>
            <a:chExt cx="2910377" cy="1581235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3341BD06-650B-4DF0-945A-1325D71506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5151" b="29181"/>
            <a:stretch/>
          </p:blipFill>
          <p:spPr>
            <a:xfrm>
              <a:off x="136358" y="287002"/>
              <a:ext cx="2322863" cy="1581235"/>
            </a:xfrm>
            <a:prstGeom prst="rect">
              <a:avLst/>
            </a:prstGeom>
          </p:spPr>
        </p:pic>
        <p:sp>
          <p:nvSpPr>
            <p:cNvPr id="9" name="TextBox 22">
              <a:extLst>
                <a:ext uri="{FF2B5EF4-FFF2-40B4-BE49-F238E27FC236}">
                  <a16:creationId xmlns:a16="http://schemas.microsoft.com/office/drawing/2014/main" id="{DD6BF38E-7A52-4C2A-A68C-7147A09F9727}"/>
                </a:ext>
              </a:extLst>
            </p:cNvPr>
            <p:cNvSpPr txBox="1"/>
            <p:nvPr/>
          </p:nvSpPr>
          <p:spPr>
            <a:xfrm>
              <a:off x="1557569" y="340966"/>
              <a:ext cx="14891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562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B4E0947E-A98C-42C6-BC54-BF0286FE929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9056"/>
          <a:stretch/>
        </p:blipFill>
        <p:spPr>
          <a:xfrm>
            <a:off x="207107" y="2923518"/>
            <a:ext cx="2976479" cy="1999210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5A651FAF-C346-4B1E-9FD9-68A2519844EF}"/>
              </a:ext>
            </a:extLst>
          </p:cNvPr>
          <p:cNvGrpSpPr/>
          <p:nvPr/>
        </p:nvGrpSpPr>
        <p:grpSpPr>
          <a:xfrm>
            <a:off x="2677223" y="2982734"/>
            <a:ext cx="2423249" cy="1770486"/>
            <a:chOff x="4349694" y="1569208"/>
            <a:chExt cx="2464605" cy="193924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3B2580E6-0206-409E-A171-B00AD538485E}"/>
                </a:ext>
              </a:extLst>
            </p:cNvPr>
            <p:cNvGrpSpPr/>
            <p:nvPr/>
          </p:nvGrpSpPr>
          <p:grpSpPr>
            <a:xfrm>
              <a:off x="4349694" y="1569208"/>
              <a:ext cx="2205214" cy="1939241"/>
              <a:chOff x="692094" y="654808"/>
              <a:chExt cx="2205214" cy="1939241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6154086B-DC8A-46BA-A3A6-03090C11AE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785" r="45492" b="7322"/>
              <a:stretch/>
            </p:blipFill>
            <p:spPr>
              <a:xfrm>
                <a:off x="922789" y="654808"/>
                <a:ext cx="1974519" cy="1939241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2805122-50E3-4C3E-82E2-87851312F2CE}"/>
                  </a:ext>
                </a:extLst>
              </p:cNvPr>
              <p:cNvSpPr txBox="1"/>
              <p:nvPr/>
            </p:nvSpPr>
            <p:spPr>
              <a:xfrm rot="16200000">
                <a:off x="254559" y="1157681"/>
                <a:ext cx="118284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0D7FA8E-C1F2-4DAF-8CFA-5E5242BACCF7}"/>
                </a:ext>
              </a:extLst>
            </p:cNvPr>
            <p:cNvSpPr txBox="1"/>
            <p:nvPr/>
          </p:nvSpPr>
          <p:spPr>
            <a:xfrm>
              <a:off x="5631451" y="1634546"/>
              <a:ext cx="11828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36P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B2C3CD4-D4EB-4025-BCA2-9F2096A8E47C}"/>
              </a:ext>
            </a:extLst>
          </p:cNvPr>
          <p:cNvSpPr txBox="1"/>
          <p:nvPr/>
        </p:nvSpPr>
        <p:spPr>
          <a:xfrm>
            <a:off x="1726369" y="3073717"/>
            <a:ext cx="742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F-1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D04D12D-EF4B-471E-A397-049ECD3FE9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2645" r="13857" b="35069"/>
          <a:stretch/>
        </p:blipFill>
        <p:spPr>
          <a:xfrm>
            <a:off x="7394638" y="2907835"/>
            <a:ext cx="2362465" cy="1870591"/>
          </a:xfrm>
          <a:prstGeom prst="rect">
            <a:avLst/>
          </a:prstGeom>
        </p:spPr>
      </p:pic>
      <p:pic>
        <p:nvPicPr>
          <p:cNvPr id="18" name="Picture 17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E05626D0-10D4-41E1-8622-FB79E2B566B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7" r="37587" b="19176"/>
          <a:stretch/>
        </p:blipFill>
        <p:spPr>
          <a:xfrm>
            <a:off x="9988183" y="2780496"/>
            <a:ext cx="1802481" cy="187059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AA55056-2F4C-4B6B-9721-456DB5E1DF1B}"/>
              </a:ext>
            </a:extLst>
          </p:cNvPr>
          <p:cNvSpPr txBox="1"/>
          <p:nvPr/>
        </p:nvSpPr>
        <p:spPr>
          <a:xfrm>
            <a:off x="10240459" y="2956924"/>
            <a:ext cx="7791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E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0D34F8-0E39-49C2-A07D-AF69132EC9E9}"/>
              </a:ext>
            </a:extLst>
          </p:cNvPr>
          <p:cNvSpPr txBox="1"/>
          <p:nvPr/>
        </p:nvSpPr>
        <p:spPr>
          <a:xfrm>
            <a:off x="7864886" y="2956925"/>
            <a:ext cx="742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ET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D0572B0-302A-4B4C-A89B-A192D4932AE2}"/>
              </a:ext>
            </a:extLst>
          </p:cNvPr>
          <p:cNvSpPr txBox="1"/>
          <p:nvPr/>
        </p:nvSpPr>
        <p:spPr>
          <a:xfrm>
            <a:off x="11570" y="2742015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3372307-2D84-491C-98DB-4ADC595181AE}"/>
              </a:ext>
            </a:extLst>
          </p:cNvPr>
          <p:cNvSpPr txBox="1"/>
          <p:nvPr/>
        </p:nvSpPr>
        <p:spPr>
          <a:xfrm>
            <a:off x="2449809" y="2706869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D1F1DA6-121F-4421-AC40-CE6350A56A65}"/>
              </a:ext>
            </a:extLst>
          </p:cNvPr>
          <p:cNvSpPr txBox="1"/>
          <p:nvPr/>
        </p:nvSpPr>
        <p:spPr>
          <a:xfrm>
            <a:off x="4858661" y="2706868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4847BF-02F5-4D1F-BC6D-9CC1B661B24B}"/>
              </a:ext>
            </a:extLst>
          </p:cNvPr>
          <p:cNvSpPr txBox="1"/>
          <p:nvPr/>
        </p:nvSpPr>
        <p:spPr>
          <a:xfrm>
            <a:off x="7204248" y="2711884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4304480-1A19-430D-84A0-39D52AF988EB}"/>
              </a:ext>
            </a:extLst>
          </p:cNvPr>
          <p:cNvSpPr txBox="1"/>
          <p:nvPr/>
        </p:nvSpPr>
        <p:spPr>
          <a:xfrm>
            <a:off x="9615895" y="2714014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07F2B056-A798-4C78-910F-8C66602D2B4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9945"/>
          <a:stretch/>
        </p:blipFill>
        <p:spPr>
          <a:xfrm>
            <a:off x="4404220" y="5071280"/>
            <a:ext cx="2976479" cy="51703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A4DD3DD7-FCF7-43EF-AEB4-444E97527E88}"/>
              </a:ext>
            </a:extLst>
          </p:cNvPr>
          <p:cNvSpPr txBox="1"/>
          <p:nvPr/>
        </p:nvSpPr>
        <p:spPr>
          <a:xfrm>
            <a:off x="3492073" y="4704651"/>
            <a:ext cx="116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CRL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B914D8-C2F7-4A7F-8B15-857319CAB940}"/>
              </a:ext>
            </a:extLst>
          </p:cNvPr>
          <p:cNvSpPr txBox="1"/>
          <p:nvPr/>
        </p:nvSpPr>
        <p:spPr>
          <a:xfrm>
            <a:off x="5892460" y="4705726"/>
            <a:ext cx="116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CRL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1FF86F-2A27-460D-938D-8285359CA694}"/>
              </a:ext>
            </a:extLst>
          </p:cNvPr>
          <p:cNvSpPr txBox="1"/>
          <p:nvPr/>
        </p:nvSpPr>
        <p:spPr>
          <a:xfrm>
            <a:off x="8269980" y="4700621"/>
            <a:ext cx="116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CRL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0379D01-8609-44EE-9F75-9ED925DC500B}"/>
              </a:ext>
            </a:extLst>
          </p:cNvPr>
          <p:cNvSpPr txBox="1"/>
          <p:nvPr/>
        </p:nvSpPr>
        <p:spPr>
          <a:xfrm>
            <a:off x="10557004" y="4700621"/>
            <a:ext cx="116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CRL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44A7314-5CC7-47D9-9748-84B7BC0F4F0D}"/>
              </a:ext>
            </a:extLst>
          </p:cNvPr>
          <p:cNvSpPr txBox="1"/>
          <p:nvPr/>
        </p:nvSpPr>
        <p:spPr>
          <a:xfrm>
            <a:off x="2639259" y="5720129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A9A436B4-2EF6-4132-A542-C5BE243296F4}"/>
              </a:ext>
            </a:extLst>
          </p:cNvPr>
          <p:cNvGrpSpPr/>
          <p:nvPr/>
        </p:nvGrpSpPr>
        <p:grpSpPr>
          <a:xfrm>
            <a:off x="6320806" y="5892295"/>
            <a:ext cx="2287024" cy="2878343"/>
            <a:chOff x="8927592" y="5669990"/>
            <a:chExt cx="2287024" cy="2878343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DB723F48-D8B4-424C-A40C-D7E5DDADF28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192045" y="5835682"/>
              <a:ext cx="1592309" cy="2712651"/>
            </a:xfrm>
            <a:prstGeom prst="rect">
              <a:avLst/>
            </a:prstGeom>
          </p:spPr>
        </p:pic>
        <p:sp>
          <p:nvSpPr>
            <p:cNvPr id="34" name="TextBox 55">
              <a:extLst>
                <a:ext uri="{FF2B5EF4-FFF2-40B4-BE49-F238E27FC236}">
                  <a16:creationId xmlns:a16="http://schemas.microsoft.com/office/drawing/2014/main" id="{0FA669CA-4449-4540-860D-12DB2D330B13}"/>
                </a:ext>
              </a:extLst>
            </p:cNvPr>
            <p:cNvSpPr txBox="1"/>
            <p:nvPr/>
          </p:nvSpPr>
          <p:spPr>
            <a:xfrm rot="16200000">
              <a:off x="8078172" y="6623413"/>
              <a:ext cx="20066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lonies/2000 cells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A38C86D-40D3-471B-A6AE-FCC2580B37C2}"/>
                </a:ext>
              </a:extLst>
            </p:cNvPr>
            <p:cNvSpPr txBox="1"/>
            <p:nvPr/>
          </p:nvSpPr>
          <p:spPr>
            <a:xfrm>
              <a:off x="9683342" y="5669990"/>
              <a:ext cx="15312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V4-11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0C0D9569-64A3-4AD8-9ACD-BB46BB0BBD28}"/>
              </a:ext>
            </a:extLst>
          </p:cNvPr>
          <p:cNvSpPr txBox="1"/>
          <p:nvPr/>
        </p:nvSpPr>
        <p:spPr>
          <a:xfrm>
            <a:off x="6021390" y="5720129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978A103F-F5FD-443E-8441-85F41DDE6179}"/>
              </a:ext>
            </a:extLst>
          </p:cNvPr>
          <p:cNvGrpSpPr/>
          <p:nvPr/>
        </p:nvGrpSpPr>
        <p:grpSpPr>
          <a:xfrm>
            <a:off x="2984165" y="6123837"/>
            <a:ext cx="2976479" cy="2212913"/>
            <a:chOff x="20966" y="1445357"/>
            <a:chExt cx="2976479" cy="2212913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17E4277-FC97-4FBA-AE29-50F616375F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108" r="42593" b="8584"/>
            <a:stretch/>
          </p:blipFill>
          <p:spPr>
            <a:xfrm>
              <a:off x="458684" y="1478960"/>
              <a:ext cx="1846275" cy="1530326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8AEF0CE5-4A97-4D96-B83B-2FE16F3E75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9593"/>
            <a:stretch/>
          </p:blipFill>
          <p:spPr>
            <a:xfrm>
              <a:off x="20966" y="3132138"/>
              <a:ext cx="2976479" cy="526132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F9A0E1B-B32F-4918-AF48-7957821EFAF7}"/>
                </a:ext>
              </a:extLst>
            </p:cNvPr>
            <p:cNvSpPr txBox="1"/>
            <p:nvPr/>
          </p:nvSpPr>
          <p:spPr>
            <a:xfrm>
              <a:off x="1035816" y="2947427"/>
              <a:ext cx="11032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RL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36AF51F-9063-4159-9C13-5DABB4A80116}"/>
                </a:ext>
              </a:extLst>
            </p:cNvPr>
            <p:cNvSpPr txBox="1"/>
            <p:nvPr/>
          </p:nvSpPr>
          <p:spPr>
            <a:xfrm rot="16200000">
              <a:off x="-258637" y="1843082"/>
              <a:ext cx="11032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42" name="TextBox 22">
              <a:extLst>
                <a:ext uri="{FF2B5EF4-FFF2-40B4-BE49-F238E27FC236}">
                  <a16:creationId xmlns:a16="http://schemas.microsoft.com/office/drawing/2014/main" id="{BD9267A2-3085-4F06-832D-E24100B9C5CD}"/>
                </a:ext>
              </a:extLst>
            </p:cNvPr>
            <p:cNvSpPr txBox="1"/>
            <p:nvPr/>
          </p:nvSpPr>
          <p:spPr>
            <a:xfrm>
              <a:off x="1454359" y="1518029"/>
              <a:ext cx="14891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V4-11</a:t>
              </a: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80758823-8D45-4D75-BCEC-8B900BD572DA}"/>
              </a:ext>
            </a:extLst>
          </p:cNvPr>
          <p:cNvSpPr txBox="1"/>
          <p:nvPr/>
        </p:nvSpPr>
        <p:spPr>
          <a:xfrm>
            <a:off x="1509292" y="35628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2BF3C3C-AC3F-4C54-B921-FB33B7CDEED8}"/>
              </a:ext>
            </a:extLst>
          </p:cNvPr>
          <p:cNvSpPr txBox="1"/>
          <p:nvPr/>
        </p:nvSpPr>
        <p:spPr>
          <a:xfrm>
            <a:off x="6513042" y="30213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5" name="Chart 44">
            <a:extLst>
              <a:ext uri="{FF2B5EF4-FFF2-40B4-BE49-F238E27FC236}">
                <a16:creationId xmlns:a16="http://schemas.microsoft.com/office/drawing/2014/main" id="{BA0CFF31-02C6-49C5-9A08-302C6D689200}"/>
              </a:ext>
            </a:extLst>
          </p:cNvPr>
          <p:cNvGraphicFramePr>
            <a:graphicFrameLocks/>
          </p:cNvGraphicFramePr>
          <p:nvPr/>
        </p:nvGraphicFramePr>
        <p:xfrm>
          <a:off x="7761660" y="245656"/>
          <a:ext cx="2362465" cy="22383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6" name="TextBox 45">
            <a:extLst>
              <a:ext uri="{FF2B5EF4-FFF2-40B4-BE49-F238E27FC236}">
                <a16:creationId xmlns:a16="http://schemas.microsoft.com/office/drawing/2014/main" id="{6928DB37-F824-4115-8565-4F4CF26833C3}"/>
              </a:ext>
            </a:extLst>
          </p:cNvPr>
          <p:cNvSpPr txBox="1"/>
          <p:nvPr/>
        </p:nvSpPr>
        <p:spPr>
          <a:xfrm rot="16200000">
            <a:off x="6374195" y="776287"/>
            <a:ext cx="23932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CRL2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pic>
        <p:nvPicPr>
          <p:cNvPr id="2" name="Picture 1" descr="A blurry image of a black oval&#10;&#10;Description automatically generated">
            <a:extLst>
              <a:ext uri="{FF2B5EF4-FFF2-40B4-BE49-F238E27FC236}">
                <a16:creationId xmlns:a16="http://schemas.microsoft.com/office/drawing/2014/main" id="{39F73695-89E0-B950-D97C-D940DF01B10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839"/>
          <a:stretch/>
        </p:blipFill>
        <p:spPr>
          <a:xfrm>
            <a:off x="2396876" y="1143063"/>
            <a:ext cx="2423954" cy="335942"/>
          </a:xfrm>
          <a:prstGeom prst="rect">
            <a:avLst/>
          </a:prstGeom>
        </p:spPr>
      </p:pic>
      <p:pic>
        <p:nvPicPr>
          <p:cNvPr id="3" name="Picture 2" descr="A blurry black oval object&#10;&#10;Description automatically generated">
            <a:extLst>
              <a:ext uri="{FF2B5EF4-FFF2-40B4-BE49-F238E27FC236}">
                <a16:creationId xmlns:a16="http://schemas.microsoft.com/office/drawing/2014/main" id="{893840D4-2C4D-08AC-A1D8-0F92EBE17AF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876" y="1584424"/>
            <a:ext cx="2423953" cy="2845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B1895D-87E7-AA93-F4E2-27E537914560}"/>
              </a:ext>
            </a:extLst>
          </p:cNvPr>
          <p:cNvSpPr txBox="1"/>
          <p:nvPr/>
        </p:nvSpPr>
        <p:spPr>
          <a:xfrm>
            <a:off x="1641609" y="1569993"/>
            <a:ext cx="1510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4C4DFA-B4A3-658A-E50D-650B094EB34D}"/>
              </a:ext>
            </a:extLst>
          </p:cNvPr>
          <p:cNvSpPr txBox="1"/>
          <p:nvPr/>
        </p:nvSpPr>
        <p:spPr>
          <a:xfrm>
            <a:off x="1899531" y="1139745"/>
            <a:ext cx="1510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5353F2D-F19D-B3D3-1E44-33D4C91230B0}"/>
              </a:ext>
            </a:extLst>
          </p:cNvPr>
          <p:cNvSpPr txBox="1"/>
          <p:nvPr/>
        </p:nvSpPr>
        <p:spPr>
          <a:xfrm rot="18666714">
            <a:off x="2575440" y="533222"/>
            <a:ext cx="1118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P53 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0A710E5-770B-94AE-561F-61F3542F4FE3}"/>
              </a:ext>
            </a:extLst>
          </p:cNvPr>
          <p:cNvSpPr txBox="1"/>
          <p:nvPr/>
        </p:nvSpPr>
        <p:spPr>
          <a:xfrm rot="18666714">
            <a:off x="3334868" y="564662"/>
            <a:ext cx="1118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P53 KO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E1A49AB-E498-55F4-64AA-157918E1E35A}"/>
              </a:ext>
            </a:extLst>
          </p:cNvPr>
          <p:cNvSpPr txBox="1"/>
          <p:nvPr/>
        </p:nvSpPr>
        <p:spPr>
          <a:xfrm rot="18666714">
            <a:off x="4013312" y="544519"/>
            <a:ext cx="1118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P53 KO2</a:t>
            </a:r>
          </a:p>
        </p:txBody>
      </p:sp>
    </p:spTree>
    <p:extLst>
      <p:ext uri="{BB962C8B-B14F-4D97-AF65-F5344CB8AC3E}">
        <p14:creationId xmlns:p14="http://schemas.microsoft.com/office/powerpoint/2010/main" val="1382465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DE44A5D-B7F2-40F1-4063-806426B41689}"/>
              </a:ext>
            </a:extLst>
          </p:cNvPr>
          <p:cNvSpPr txBox="1"/>
          <p:nvPr/>
        </p:nvSpPr>
        <p:spPr>
          <a:xfrm>
            <a:off x="138953" y="8774668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3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800DF27E-7541-4626-9299-743C3C416295}"/>
              </a:ext>
            </a:extLst>
          </p:cNvPr>
          <p:cNvGrpSpPr/>
          <p:nvPr/>
        </p:nvGrpSpPr>
        <p:grpSpPr>
          <a:xfrm>
            <a:off x="6481125" y="179330"/>
            <a:ext cx="5076158" cy="3694971"/>
            <a:chOff x="528651" y="648188"/>
            <a:chExt cx="5076158" cy="3694971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DEB6BB69-6D86-4EBE-939A-3B58277F1D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651" y="648188"/>
              <a:ext cx="5076158" cy="3646730"/>
            </a:xfrm>
            <a:prstGeom prst="rect">
              <a:avLst/>
            </a:prstGeom>
          </p:spPr>
        </p:pic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9E5F8C78-9469-41DE-995C-BA8FFF2B0F98}"/>
                </a:ext>
              </a:extLst>
            </p:cNvPr>
            <p:cNvCxnSpPr>
              <a:cxnSpLocks/>
            </p:cNvCxnSpPr>
            <p:nvPr/>
          </p:nvCxnSpPr>
          <p:spPr>
            <a:xfrm>
              <a:off x="3229585" y="4066160"/>
              <a:ext cx="2110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A62C0968-450F-4FED-99D2-A9796BB892A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60315" y="4066159"/>
              <a:ext cx="2053355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51C3BBA-2629-47A9-8CC2-DC73DE6CB90C}"/>
                </a:ext>
              </a:extLst>
            </p:cNvPr>
            <p:cNvSpPr txBox="1"/>
            <p:nvPr/>
          </p:nvSpPr>
          <p:spPr>
            <a:xfrm>
              <a:off x="1755403" y="4066160"/>
              <a:ext cx="17554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p in KO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9C459E3-67B1-48A5-92BC-918239C62C20}"/>
                </a:ext>
              </a:extLst>
            </p:cNvPr>
            <p:cNvSpPr txBox="1"/>
            <p:nvPr/>
          </p:nvSpPr>
          <p:spPr>
            <a:xfrm>
              <a:off x="3462697" y="4066159"/>
              <a:ext cx="17554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p in WT</a:t>
              </a: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D63CA53E-6209-4DB5-98E5-DF60E2EEEE9D}"/>
              </a:ext>
            </a:extLst>
          </p:cNvPr>
          <p:cNvSpPr txBox="1"/>
          <p:nvPr/>
        </p:nvSpPr>
        <p:spPr>
          <a:xfrm>
            <a:off x="0" y="1332"/>
            <a:ext cx="3721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DADE022A-2881-44D9-9A66-DF775A5D0169}"/>
              </a:ext>
            </a:extLst>
          </p:cNvPr>
          <p:cNvGrpSpPr/>
          <p:nvPr/>
        </p:nvGrpSpPr>
        <p:grpSpPr>
          <a:xfrm>
            <a:off x="12912" y="4589891"/>
            <a:ext cx="5603929" cy="3697589"/>
            <a:chOff x="6074072" y="3983638"/>
            <a:chExt cx="4979674" cy="3654134"/>
          </a:xfrm>
        </p:grpSpPr>
        <p:pic>
          <p:nvPicPr>
            <p:cNvPr id="41" name="Picture 40" descr="A white square with red and blue dots&#10;&#10;Description automatically generated">
              <a:extLst>
                <a:ext uri="{FF2B5EF4-FFF2-40B4-BE49-F238E27FC236}">
                  <a16:creationId xmlns:a16="http://schemas.microsoft.com/office/drawing/2014/main" id="{83538D12-F99B-4BE3-A61B-EBA5FA4B2F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34634" y="4460038"/>
              <a:ext cx="4419112" cy="3177734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DB96AE7-DBBE-4263-B71B-0313AAB2ECB2}"/>
                </a:ext>
              </a:extLst>
            </p:cNvPr>
            <p:cNvSpPr txBox="1"/>
            <p:nvPr/>
          </p:nvSpPr>
          <p:spPr>
            <a:xfrm>
              <a:off x="6074072" y="3983638"/>
              <a:ext cx="879655" cy="415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1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6287E3CB-F81D-41D9-B878-5707010E6376}"/>
              </a:ext>
            </a:extLst>
          </p:cNvPr>
          <p:cNvGrpSpPr/>
          <p:nvPr/>
        </p:nvGrpSpPr>
        <p:grpSpPr>
          <a:xfrm>
            <a:off x="7114033" y="4092011"/>
            <a:ext cx="4136051" cy="5041297"/>
            <a:chOff x="670617" y="4032062"/>
            <a:chExt cx="3937011" cy="4742605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8A397C9C-E8B2-49C8-ADD5-398251586112}"/>
                </a:ext>
              </a:extLst>
            </p:cNvPr>
            <p:cNvGrpSpPr/>
            <p:nvPr/>
          </p:nvGrpSpPr>
          <p:grpSpPr>
            <a:xfrm>
              <a:off x="670617" y="4276551"/>
              <a:ext cx="3937011" cy="4498116"/>
              <a:chOff x="-2580964" y="1624773"/>
              <a:chExt cx="3810871" cy="4972407"/>
            </a:xfrm>
          </p:grpSpPr>
          <p:pic>
            <p:nvPicPr>
              <p:cNvPr id="49" name="Picture 2">
                <a:extLst>
                  <a:ext uri="{FF2B5EF4-FFF2-40B4-BE49-F238E27FC236}">
                    <a16:creationId xmlns:a16="http://schemas.microsoft.com/office/drawing/2014/main" id="{B3C6E9AF-3A37-4D8C-AD24-A6DF91B8138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007"/>
              <a:stretch/>
            </p:blipFill>
            <p:spPr bwMode="auto">
              <a:xfrm>
                <a:off x="415705" y="1624773"/>
                <a:ext cx="814202" cy="49724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0" name="Picture 2">
                <a:extLst>
                  <a:ext uri="{FF2B5EF4-FFF2-40B4-BE49-F238E27FC236}">
                    <a16:creationId xmlns:a16="http://schemas.microsoft.com/office/drawing/2014/main" id="{E2A25B0B-15EC-47B5-8013-A438B3A3BC2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5859"/>
              <a:stretch/>
            </p:blipFill>
            <p:spPr bwMode="auto">
              <a:xfrm>
                <a:off x="-2580964" y="1624773"/>
                <a:ext cx="2996669" cy="49724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4E5BD85-ABC6-4393-8B67-8BCFB9EAB07C}"/>
                </a:ext>
              </a:extLst>
            </p:cNvPr>
            <p:cNvSpPr txBox="1"/>
            <p:nvPr/>
          </p:nvSpPr>
          <p:spPr>
            <a:xfrm>
              <a:off x="938580" y="4032063"/>
              <a:ext cx="1695672" cy="332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RL2 W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64D6CCD-670A-4C39-B7FC-E443571810C2}"/>
                </a:ext>
              </a:extLst>
            </p:cNvPr>
            <p:cNvSpPr txBox="1"/>
            <p:nvPr/>
          </p:nvSpPr>
          <p:spPr>
            <a:xfrm>
              <a:off x="2505585" y="4032062"/>
              <a:ext cx="16956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RL2 KO</a:t>
              </a:r>
            </a:p>
          </p:txBody>
        </p:sp>
      </p:grpSp>
      <p:pic>
        <p:nvPicPr>
          <p:cNvPr id="53" name="Picture 52">
            <a:extLst>
              <a:ext uri="{FF2B5EF4-FFF2-40B4-BE49-F238E27FC236}">
                <a16:creationId xmlns:a16="http://schemas.microsoft.com/office/drawing/2014/main" id="{DB523030-645B-4982-829A-540248FAAF3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9" b="2459"/>
          <a:stretch/>
        </p:blipFill>
        <p:spPr>
          <a:xfrm>
            <a:off x="391395" y="329117"/>
            <a:ext cx="5360059" cy="3773586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656CDC34-82C3-4071-80EE-00919BB4DE7B}"/>
              </a:ext>
            </a:extLst>
          </p:cNvPr>
          <p:cNvSpPr txBox="1"/>
          <p:nvPr/>
        </p:nvSpPr>
        <p:spPr>
          <a:xfrm>
            <a:off x="5751454" y="32737"/>
            <a:ext cx="879655" cy="378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6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3135A23-5360-441C-935C-8E839628F79E}"/>
              </a:ext>
            </a:extLst>
          </p:cNvPr>
          <p:cNvSpPr txBox="1"/>
          <p:nvPr/>
        </p:nvSpPr>
        <p:spPr>
          <a:xfrm>
            <a:off x="5790527" y="4597820"/>
            <a:ext cx="879655" cy="378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61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415325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19B977E1-16F0-249F-429B-7F9B52F8C676}"/>
              </a:ext>
            </a:extLst>
          </p:cNvPr>
          <p:cNvSpPr txBox="1"/>
          <p:nvPr/>
        </p:nvSpPr>
        <p:spPr>
          <a:xfrm>
            <a:off x="6371226" y="306118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2939E1C-43D4-1D09-0225-72FF5829DE84}"/>
              </a:ext>
            </a:extLst>
          </p:cNvPr>
          <p:cNvSpPr txBox="1"/>
          <p:nvPr/>
        </p:nvSpPr>
        <p:spPr>
          <a:xfrm>
            <a:off x="88309" y="8711529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4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95C82E3D-E7CE-44A0-9EE5-DC38B2FF2E80}"/>
              </a:ext>
            </a:extLst>
          </p:cNvPr>
          <p:cNvGrpSpPr/>
          <p:nvPr/>
        </p:nvGrpSpPr>
        <p:grpSpPr>
          <a:xfrm>
            <a:off x="1189728" y="940996"/>
            <a:ext cx="3881339" cy="1854944"/>
            <a:chOff x="6585510" y="508729"/>
            <a:chExt cx="3881339" cy="185494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EA9FF7B-CE65-4AD3-B974-0B45C395DEE7}"/>
                </a:ext>
              </a:extLst>
            </p:cNvPr>
            <p:cNvGrpSpPr/>
            <p:nvPr/>
          </p:nvGrpSpPr>
          <p:grpSpPr>
            <a:xfrm>
              <a:off x="6585510" y="547397"/>
              <a:ext cx="3881339" cy="1816276"/>
              <a:chOff x="1471322" y="980344"/>
              <a:chExt cx="3881339" cy="1816276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51F5F4DC-D286-45FF-9717-A0B4AFEF07B4}"/>
                  </a:ext>
                </a:extLst>
              </p:cNvPr>
              <p:cNvGrpSpPr/>
              <p:nvPr/>
            </p:nvGrpSpPr>
            <p:grpSpPr>
              <a:xfrm>
                <a:off x="1471322" y="1858481"/>
                <a:ext cx="3813693" cy="938139"/>
                <a:chOff x="1471322" y="1858481"/>
                <a:chExt cx="3813693" cy="938139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A8FABF68-6E41-4D8B-8C0C-D90A9F7407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84665" y="1876795"/>
                  <a:ext cx="2800350" cy="323850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0EB54719-EFFE-4FE4-AA77-69802D40B1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84665" y="2200645"/>
                  <a:ext cx="2800350" cy="253811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D54804BA-8D66-48BA-BE80-3EEA64C930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40000" contrast="64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84665" y="2511606"/>
                  <a:ext cx="2781300" cy="253811"/>
                </a:xfrm>
                <a:prstGeom prst="rect">
                  <a:avLst/>
                </a:prstGeom>
              </p:spPr>
            </p:pic>
            <p:sp>
              <p:nvSpPr>
                <p:cNvPr id="15" name="TextBox 10">
                  <a:extLst>
                    <a:ext uri="{FF2B5EF4-FFF2-40B4-BE49-F238E27FC236}">
                      <a16:creationId xmlns:a16="http://schemas.microsoft.com/office/drawing/2014/main" id="{CE698995-6B74-4F52-860A-7FF8C835144E}"/>
                    </a:ext>
                  </a:extLst>
                </p:cNvPr>
                <p:cNvSpPr txBox="1"/>
                <p:nvPr/>
              </p:nvSpPr>
              <p:spPr>
                <a:xfrm>
                  <a:off x="1596313" y="1858481"/>
                  <a:ext cx="117565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STAT1</a:t>
                  </a:r>
                </a:p>
              </p:txBody>
            </p:sp>
            <p:sp>
              <p:nvSpPr>
                <p:cNvPr id="16" name="TextBox 11">
                  <a:extLst>
                    <a:ext uri="{FF2B5EF4-FFF2-40B4-BE49-F238E27FC236}">
                      <a16:creationId xmlns:a16="http://schemas.microsoft.com/office/drawing/2014/main" id="{FBA0F406-90AA-4F20-8A5D-7ABB615B5D07}"/>
                    </a:ext>
                  </a:extLst>
                </p:cNvPr>
                <p:cNvSpPr txBox="1"/>
                <p:nvPr/>
              </p:nvSpPr>
              <p:spPr>
                <a:xfrm>
                  <a:off x="1471322" y="2147944"/>
                  <a:ext cx="117565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Lamin B1</a:t>
                  </a:r>
                </a:p>
              </p:txBody>
            </p:sp>
            <p:sp>
              <p:nvSpPr>
                <p:cNvPr id="17" name="TextBox 12">
                  <a:extLst>
                    <a:ext uri="{FF2B5EF4-FFF2-40B4-BE49-F238E27FC236}">
                      <a16:creationId xmlns:a16="http://schemas.microsoft.com/office/drawing/2014/main" id="{D146DDFE-8A47-4556-8355-E86EEFE8A82D}"/>
                    </a:ext>
                  </a:extLst>
                </p:cNvPr>
                <p:cNvSpPr txBox="1"/>
                <p:nvPr/>
              </p:nvSpPr>
              <p:spPr>
                <a:xfrm>
                  <a:off x="1536636" y="2488843"/>
                  <a:ext cx="117565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4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</a:p>
              </p:txBody>
            </p:sp>
          </p:grpSp>
          <p:sp>
            <p:nvSpPr>
              <p:cNvPr id="9" name="TextBox 3">
                <a:extLst>
                  <a:ext uri="{FF2B5EF4-FFF2-40B4-BE49-F238E27FC236}">
                    <a16:creationId xmlns:a16="http://schemas.microsoft.com/office/drawing/2014/main" id="{3588260E-E665-4C0F-BA9B-DE0A009D0C35}"/>
                  </a:ext>
                </a:extLst>
              </p:cNvPr>
              <p:cNvSpPr txBox="1"/>
              <p:nvPr/>
            </p:nvSpPr>
            <p:spPr>
              <a:xfrm>
                <a:off x="2771970" y="980344"/>
                <a:ext cx="1175657" cy="307777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400" b="1" dirty="0">
                    <a:latin typeface="Arial"/>
                    <a:cs typeface="Arial"/>
                  </a:rPr>
                  <a:t>sgControl</a:t>
                </a:r>
              </a:p>
            </p:txBody>
          </p:sp>
          <p:sp>
            <p:nvSpPr>
              <p:cNvPr id="10" name="TextBox 5">
                <a:extLst>
                  <a:ext uri="{FF2B5EF4-FFF2-40B4-BE49-F238E27FC236}">
                    <a16:creationId xmlns:a16="http://schemas.microsoft.com/office/drawing/2014/main" id="{D196FDDA-C2BE-49F0-B67E-3AEA8EEAFD20}"/>
                  </a:ext>
                </a:extLst>
              </p:cNvPr>
              <p:cNvSpPr txBox="1"/>
              <p:nvPr/>
            </p:nvSpPr>
            <p:spPr>
              <a:xfrm>
                <a:off x="1589801" y="1254694"/>
                <a:ext cx="37511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M-CSF          +           -             +           -</a:t>
                </a:r>
              </a:p>
            </p:txBody>
          </p:sp>
          <p:sp>
            <p:nvSpPr>
              <p:cNvPr id="11" name="TextBox 6">
                <a:extLst>
                  <a:ext uri="{FF2B5EF4-FFF2-40B4-BE49-F238E27FC236}">
                    <a16:creationId xmlns:a16="http://schemas.microsoft.com/office/drawing/2014/main" id="{15D2A4B8-B30C-4C5D-899C-27A80DE350C2}"/>
                  </a:ext>
                </a:extLst>
              </p:cNvPr>
              <p:cNvSpPr txBox="1"/>
              <p:nvPr/>
            </p:nvSpPr>
            <p:spPr>
              <a:xfrm>
                <a:off x="1601464" y="1536527"/>
                <a:ext cx="37511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C    N    C    N     C    N    C    N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5BC82C-6083-4C04-B715-137DA9E9D830}"/>
                </a:ext>
              </a:extLst>
            </p:cNvPr>
            <p:cNvSpPr txBox="1"/>
            <p:nvPr/>
          </p:nvSpPr>
          <p:spPr>
            <a:xfrm>
              <a:off x="9149851" y="508729"/>
              <a:ext cx="12303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gCCRL2 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1902547" y="4909850"/>
            <a:ext cx="6713523" cy="3330761"/>
            <a:chOff x="5048337" y="4854875"/>
            <a:chExt cx="6713523" cy="3330761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8B7DA85-CFBE-1037-D0CB-995A9FC33A4A}"/>
                </a:ext>
              </a:extLst>
            </p:cNvPr>
            <p:cNvSpPr txBox="1"/>
            <p:nvPr/>
          </p:nvSpPr>
          <p:spPr>
            <a:xfrm>
              <a:off x="5071067" y="4854875"/>
              <a:ext cx="174859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C7411AE-64D6-4655-865D-70C481A6E1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r="61083" b="17465"/>
            <a:stretch/>
          </p:blipFill>
          <p:spPr>
            <a:xfrm>
              <a:off x="5048337" y="5213539"/>
              <a:ext cx="3197984" cy="2972097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045D1C0-4580-47B1-BCA6-8F075732ED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7394"/>
            <a:stretch/>
          </p:blipFill>
          <p:spPr>
            <a:xfrm>
              <a:off x="8246321" y="5099786"/>
              <a:ext cx="3515539" cy="2928455"/>
            </a:xfrm>
            <a:prstGeom prst="rect">
              <a:avLst/>
            </a:prstGeom>
          </p:spPr>
        </p:pic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19B977E1-16F0-249F-429B-7F9B52F8C676}"/>
              </a:ext>
            </a:extLst>
          </p:cNvPr>
          <p:cNvSpPr txBox="1"/>
          <p:nvPr/>
        </p:nvSpPr>
        <p:spPr>
          <a:xfrm>
            <a:off x="685778" y="306119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6969397" y="2304"/>
            <a:ext cx="4020987" cy="4766337"/>
            <a:chOff x="3417304" y="-32068"/>
            <a:chExt cx="4020987" cy="476633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58" b="5173"/>
            <a:stretch/>
          </p:blipFill>
          <p:spPr>
            <a:xfrm>
              <a:off x="3417304" y="331050"/>
              <a:ext cx="4020987" cy="4403219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2110385" y="1366310"/>
              <a:ext cx="31660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b="1" i="1" dirty="0">
                  <a:latin typeface="Arial" panose="020B0604020202020204" pitchFamily="34" charset="0"/>
                  <a:cs typeface="Arial" panose="020B0604020202020204" pitchFamily="34" charset="0"/>
                </a:rPr>
                <a:t>IFIT3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168789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2"/>
          <a:srcRect r="70111"/>
          <a:stretch/>
        </p:blipFill>
        <p:spPr>
          <a:xfrm>
            <a:off x="7981116" y="4953052"/>
            <a:ext cx="1363981" cy="32377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0BCCDE3-4A65-F31F-CF78-4F20D3CACD0E}"/>
              </a:ext>
            </a:extLst>
          </p:cNvPr>
          <p:cNvSpPr txBox="1"/>
          <p:nvPr/>
        </p:nvSpPr>
        <p:spPr>
          <a:xfrm>
            <a:off x="281240" y="333798"/>
            <a:ext cx="5524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5657D7-3222-5F6D-50EF-C1BE0125C62A}"/>
              </a:ext>
            </a:extLst>
          </p:cNvPr>
          <p:cNvSpPr txBox="1"/>
          <p:nvPr/>
        </p:nvSpPr>
        <p:spPr>
          <a:xfrm rot="16200000">
            <a:off x="3255774" y="1979659"/>
            <a:ext cx="1805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SG15 normalized RPKM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89D5520-3209-1DFF-59F1-A0F7CDAECFBD}"/>
              </a:ext>
            </a:extLst>
          </p:cNvPr>
          <p:cNvGrpSpPr/>
          <p:nvPr/>
        </p:nvGrpSpPr>
        <p:grpSpPr>
          <a:xfrm>
            <a:off x="2014525" y="1685834"/>
            <a:ext cx="432082" cy="48141"/>
            <a:chOff x="5860462" y="2739030"/>
            <a:chExt cx="1053010" cy="150026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E5C7F714-235C-3B14-1F21-C7C076198206}"/>
                </a:ext>
              </a:extLst>
            </p:cNvPr>
            <p:cNvCxnSpPr>
              <a:cxnSpLocks/>
            </p:cNvCxnSpPr>
            <p:nvPr/>
          </p:nvCxnSpPr>
          <p:spPr>
            <a:xfrm>
              <a:off x="5864108" y="2739030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D6401C02-9B4C-A984-DDA9-C1E861A9100C}"/>
                </a:ext>
              </a:extLst>
            </p:cNvPr>
            <p:cNvCxnSpPr>
              <a:cxnSpLocks/>
            </p:cNvCxnSpPr>
            <p:nvPr/>
          </p:nvCxnSpPr>
          <p:spPr>
            <a:xfrm>
              <a:off x="5860462" y="2739039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9A81A8F2-8D38-3AD7-904B-0EE50AD2A7FA}"/>
                </a:ext>
              </a:extLst>
            </p:cNvPr>
            <p:cNvCxnSpPr>
              <a:cxnSpLocks/>
            </p:cNvCxnSpPr>
            <p:nvPr/>
          </p:nvCxnSpPr>
          <p:spPr>
            <a:xfrm>
              <a:off x="6913472" y="2740507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DD5D1D9-DB38-A417-0F40-18276CB67254}"/>
              </a:ext>
            </a:extLst>
          </p:cNvPr>
          <p:cNvSpPr txBox="1"/>
          <p:nvPr/>
        </p:nvSpPr>
        <p:spPr>
          <a:xfrm>
            <a:off x="1931128" y="1543661"/>
            <a:ext cx="718259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P=0.024</a:t>
            </a:r>
          </a:p>
        </p:txBody>
      </p:sp>
      <p:pic>
        <p:nvPicPr>
          <p:cNvPr id="11" name="Picture 10" descr="A graph with different colored rectangles&#10;&#10;Description automatically generated">
            <a:extLst>
              <a:ext uri="{FF2B5EF4-FFF2-40B4-BE49-F238E27FC236}">
                <a16:creationId xmlns:a16="http://schemas.microsoft.com/office/drawing/2014/main" id="{73852C82-9FF4-56D9-E87A-2AE641E07E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876"/>
          <a:stretch/>
        </p:blipFill>
        <p:spPr>
          <a:xfrm>
            <a:off x="1374599" y="1230638"/>
            <a:ext cx="1426424" cy="2798649"/>
          </a:xfrm>
          <a:prstGeom prst="rect">
            <a:avLst/>
          </a:prstGeom>
        </p:spPr>
      </p:pic>
      <p:pic>
        <p:nvPicPr>
          <p:cNvPr id="12" name="Picture 11" descr="A graph of different colored rectangles&#10;&#10;Description automatically generated">
            <a:extLst>
              <a:ext uri="{FF2B5EF4-FFF2-40B4-BE49-F238E27FC236}">
                <a16:creationId xmlns:a16="http://schemas.microsoft.com/office/drawing/2014/main" id="{2ED8CDAD-8DCA-F529-FE9D-83C43A160C0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441"/>
          <a:stretch/>
        </p:blipFill>
        <p:spPr>
          <a:xfrm>
            <a:off x="2810076" y="1347657"/>
            <a:ext cx="1445121" cy="258891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182718EE-E03D-1E02-DB84-6BE0AC7C69AA}"/>
              </a:ext>
            </a:extLst>
          </p:cNvPr>
          <p:cNvSpPr txBox="1"/>
          <p:nvPr/>
        </p:nvSpPr>
        <p:spPr>
          <a:xfrm rot="16200000">
            <a:off x="1860306" y="2045284"/>
            <a:ext cx="1711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IT3 normalized RPK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36F3A4-1D6F-2148-F3F6-19E943F8A81E}"/>
              </a:ext>
            </a:extLst>
          </p:cNvPr>
          <p:cNvSpPr txBox="1"/>
          <p:nvPr/>
        </p:nvSpPr>
        <p:spPr>
          <a:xfrm rot="16200000">
            <a:off x="369364" y="2080669"/>
            <a:ext cx="172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IT1 normalized RPK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DDCD08-DE2A-F9C5-1D30-C55935FEF559}"/>
              </a:ext>
            </a:extLst>
          </p:cNvPr>
          <p:cNvSpPr txBox="1"/>
          <p:nvPr/>
        </p:nvSpPr>
        <p:spPr>
          <a:xfrm>
            <a:off x="4467660" y="1342956"/>
            <a:ext cx="601967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C11ABCC-D801-DBC5-6D8C-67F3003E7CDB}"/>
              </a:ext>
            </a:extLst>
          </p:cNvPr>
          <p:cNvGrpSpPr/>
          <p:nvPr/>
        </p:nvGrpSpPr>
        <p:grpSpPr>
          <a:xfrm rot="10800000" flipV="1">
            <a:off x="4529125" y="1521696"/>
            <a:ext cx="425915" cy="45719"/>
            <a:chOff x="1731043" y="514441"/>
            <a:chExt cx="1047998" cy="150026"/>
          </a:xfrm>
        </p:grpSpPr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6BFD109B-E37F-7930-9A6A-A47D25DDD347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5CF83DBD-5E03-8C47-BCD0-32D2DE3FA9C0}"/>
                </a:ext>
              </a:extLst>
            </p:cNvPr>
            <p:cNvCxnSpPr/>
            <p:nvPr/>
          </p:nvCxnSpPr>
          <p:spPr>
            <a:xfrm>
              <a:off x="1731043" y="514450"/>
              <a:ext cx="0" cy="1485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E565E86-F638-0543-07F8-11856E0BE4B2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E25A861-B41F-F0A2-0DD1-E24B8BA0B47F}"/>
              </a:ext>
            </a:extLst>
          </p:cNvPr>
          <p:cNvSpPr txBox="1"/>
          <p:nvPr/>
        </p:nvSpPr>
        <p:spPr>
          <a:xfrm>
            <a:off x="4480521" y="1111111"/>
            <a:ext cx="708874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&lt;0.001</a:t>
            </a:r>
            <a:endParaRPr lang="en-US" b="1" dirty="0">
              <a:latin typeface="Arial" panose="020B0604020202020204" pitchFamily="34" charset="0"/>
              <a:ea typeface="+mn-lt"/>
              <a:cs typeface="Arial" panose="020B0604020202020204" pitchFamily="34" charset="0"/>
            </a:endParaRPr>
          </a:p>
        </p:txBody>
      </p:sp>
      <p:pic>
        <p:nvPicPr>
          <p:cNvPr id="21" name="Picture 20" descr="A graph of different colored rectangles&#10;&#10;Description automatically generated">
            <a:extLst>
              <a:ext uri="{FF2B5EF4-FFF2-40B4-BE49-F238E27FC236}">
                <a16:creationId xmlns:a16="http://schemas.microsoft.com/office/drawing/2014/main" id="{6AC9071D-6B89-2980-89C0-553C3B8DFD4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033"/>
          <a:stretch/>
        </p:blipFill>
        <p:spPr>
          <a:xfrm>
            <a:off x="4146194" y="1217437"/>
            <a:ext cx="1526337" cy="2786315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A6FCC7A0-D7D7-DFAD-371B-CAEA6DDDE8C8}"/>
              </a:ext>
            </a:extLst>
          </p:cNvPr>
          <p:cNvGrpSpPr/>
          <p:nvPr/>
        </p:nvGrpSpPr>
        <p:grpSpPr>
          <a:xfrm>
            <a:off x="4534508" y="1304673"/>
            <a:ext cx="856842" cy="45719"/>
            <a:chOff x="1728023" y="514441"/>
            <a:chExt cx="1051018" cy="150026"/>
          </a:xfrm>
        </p:grpSpPr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6F02121-A6C4-53EC-F969-42E024D05193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D4AD30BC-BD9F-1FA4-774F-4D2486604DFC}"/>
                </a:ext>
              </a:extLst>
            </p:cNvPr>
            <p:cNvCxnSpPr/>
            <p:nvPr/>
          </p:nvCxnSpPr>
          <p:spPr>
            <a:xfrm>
              <a:off x="1728023" y="514450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73488372-94DF-A8BD-4EF9-35628EB57C11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DA966F70-C91B-2538-DCFC-C5722AB7DAE5}"/>
              </a:ext>
            </a:extLst>
          </p:cNvPr>
          <p:cNvSpPr txBox="1"/>
          <p:nvPr/>
        </p:nvSpPr>
        <p:spPr>
          <a:xfrm>
            <a:off x="3051370" y="1312853"/>
            <a:ext cx="706887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BBFB9158-E0B0-EF19-C9FB-1391755CC25A}"/>
              </a:ext>
            </a:extLst>
          </p:cNvPr>
          <p:cNvGrpSpPr/>
          <p:nvPr/>
        </p:nvGrpSpPr>
        <p:grpSpPr>
          <a:xfrm rot="10800000" flipV="1">
            <a:off x="3112835" y="1491594"/>
            <a:ext cx="425915" cy="45719"/>
            <a:chOff x="1731043" y="514441"/>
            <a:chExt cx="1047998" cy="150026"/>
          </a:xfrm>
        </p:grpSpPr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77CC880D-CC0C-AF0A-675F-5ADF0B2207ED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B15CBA2D-DFB7-9D0D-ECE8-3D56F98025D4}"/>
                </a:ext>
              </a:extLst>
            </p:cNvPr>
            <p:cNvCxnSpPr/>
            <p:nvPr/>
          </p:nvCxnSpPr>
          <p:spPr>
            <a:xfrm>
              <a:off x="1731043" y="514450"/>
              <a:ext cx="0" cy="1485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AC271E64-F77A-20A3-8995-F6B98D52E85E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185D5CD0-9BCE-D037-D19C-5C19C92F0F35}"/>
              </a:ext>
            </a:extLst>
          </p:cNvPr>
          <p:cNvSpPr txBox="1"/>
          <p:nvPr/>
        </p:nvSpPr>
        <p:spPr>
          <a:xfrm>
            <a:off x="3064232" y="1081008"/>
            <a:ext cx="708874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&lt;0.001</a:t>
            </a:r>
            <a:endParaRPr lang="en-US" b="1" dirty="0">
              <a:latin typeface="Arial" panose="020B0604020202020204" pitchFamily="34" charset="0"/>
              <a:ea typeface="+mn-lt"/>
              <a:cs typeface="Arial" panose="020B0604020202020204" pitchFamily="34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789E3656-DC54-B3F9-BC71-4F12842A7BA9}"/>
              </a:ext>
            </a:extLst>
          </p:cNvPr>
          <p:cNvGrpSpPr/>
          <p:nvPr/>
        </p:nvGrpSpPr>
        <p:grpSpPr>
          <a:xfrm>
            <a:off x="3118218" y="1274571"/>
            <a:ext cx="856842" cy="52879"/>
            <a:chOff x="1728023" y="514441"/>
            <a:chExt cx="1051018" cy="150026"/>
          </a:xfrm>
        </p:grpSpPr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F284DB3C-E2E6-A351-00E1-92DEA53B27FB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B14F1965-FD74-CE94-EC9C-6BDC4EA07D4F}"/>
                </a:ext>
              </a:extLst>
            </p:cNvPr>
            <p:cNvCxnSpPr/>
            <p:nvPr/>
          </p:nvCxnSpPr>
          <p:spPr>
            <a:xfrm>
              <a:off x="1728023" y="514450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3A36DF2B-4928-E379-5965-33C774882D2E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A126BAA9-86DA-7174-4883-2CC6080CAE66}"/>
              </a:ext>
            </a:extLst>
          </p:cNvPr>
          <p:cNvSpPr txBox="1"/>
          <p:nvPr/>
        </p:nvSpPr>
        <p:spPr>
          <a:xfrm>
            <a:off x="1604897" y="1352349"/>
            <a:ext cx="601967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91E74AC0-71E5-481E-AC30-2011057F9DAB}"/>
              </a:ext>
            </a:extLst>
          </p:cNvPr>
          <p:cNvGrpSpPr/>
          <p:nvPr/>
        </p:nvGrpSpPr>
        <p:grpSpPr>
          <a:xfrm rot="10800000" flipV="1">
            <a:off x="1666362" y="1531089"/>
            <a:ext cx="425915" cy="45719"/>
            <a:chOff x="1731043" y="514441"/>
            <a:chExt cx="1047998" cy="150026"/>
          </a:xfrm>
        </p:grpSpPr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60A19E0D-D7C9-2762-7B53-EF1D79949CDB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26327F82-C1A7-0E86-2796-5FA65AC29EBE}"/>
                </a:ext>
              </a:extLst>
            </p:cNvPr>
            <p:cNvCxnSpPr/>
            <p:nvPr/>
          </p:nvCxnSpPr>
          <p:spPr>
            <a:xfrm>
              <a:off x="1731043" y="514450"/>
              <a:ext cx="0" cy="1485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FCA41A3F-1F71-E8DA-33B5-AD06769BF76C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255F7DC0-3AAB-B948-E248-09E334BD4DED}"/>
              </a:ext>
            </a:extLst>
          </p:cNvPr>
          <p:cNvSpPr txBox="1"/>
          <p:nvPr/>
        </p:nvSpPr>
        <p:spPr>
          <a:xfrm>
            <a:off x="1631468" y="1147242"/>
            <a:ext cx="708874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&lt;0.001</a:t>
            </a:r>
            <a:endParaRPr lang="en-US" b="1" dirty="0">
              <a:latin typeface="Arial" panose="020B0604020202020204" pitchFamily="34" charset="0"/>
              <a:ea typeface="+mn-lt"/>
              <a:cs typeface="Arial" panose="020B0604020202020204" pitchFamily="34" charset="0"/>
            </a:endParaRP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B8C7454-5ECD-9D1C-6777-8968B4A09CF5}"/>
              </a:ext>
            </a:extLst>
          </p:cNvPr>
          <p:cNvGrpSpPr/>
          <p:nvPr/>
        </p:nvGrpSpPr>
        <p:grpSpPr>
          <a:xfrm>
            <a:off x="1671745" y="1314066"/>
            <a:ext cx="856842" cy="45719"/>
            <a:chOff x="1728023" y="514441"/>
            <a:chExt cx="1051018" cy="150026"/>
          </a:xfrm>
        </p:grpSpPr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6912F06E-D6D5-66E7-D1F1-6A4BF98EF50A}"/>
                </a:ext>
              </a:extLst>
            </p:cNvPr>
            <p:cNvCxnSpPr/>
            <p:nvPr/>
          </p:nvCxnSpPr>
          <p:spPr>
            <a:xfrm>
              <a:off x="1731669" y="514441"/>
              <a:ext cx="1044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979A15F8-E60F-E774-7A2C-E0A1EFF9C477}"/>
                </a:ext>
              </a:extLst>
            </p:cNvPr>
            <p:cNvCxnSpPr/>
            <p:nvPr/>
          </p:nvCxnSpPr>
          <p:spPr>
            <a:xfrm>
              <a:off x="1728023" y="514450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F6544E5A-62CE-0888-E63C-29BEC506391B}"/>
                </a:ext>
              </a:extLst>
            </p:cNvPr>
            <p:cNvCxnSpPr/>
            <p:nvPr/>
          </p:nvCxnSpPr>
          <p:spPr>
            <a:xfrm>
              <a:off x="2779041" y="515918"/>
              <a:ext cx="0" cy="148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F2939E1C-43D4-1D09-0225-72FF5829DE84}"/>
              </a:ext>
            </a:extLst>
          </p:cNvPr>
          <p:cNvSpPr txBox="1"/>
          <p:nvPr/>
        </p:nvSpPr>
        <p:spPr>
          <a:xfrm>
            <a:off x="88309" y="8711529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5</a:t>
            </a:r>
          </a:p>
        </p:txBody>
      </p:sp>
      <p:pic>
        <p:nvPicPr>
          <p:cNvPr id="47" name="Picture 46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0A8C5B2D-BED0-2584-2D62-E5F010047F4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3757" y="217347"/>
            <a:ext cx="3520726" cy="4400907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F0BCCDE3-4A65-F31F-CF78-4F20D3CACD0E}"/>
              </a:ext>
            </a:extLst>
          </p:cNvPr>
          <p:cNvSpPr txBox="1"/>
          <p:nvPr/>
        </p:nvSpPr>
        <p:spPr>
          <a:xfrm>
            <a:off x="5813892" y="328942"/>
            <a:ext cx="5524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9318" y="6767934"/>
            <a:ext cx="2682020" cy="1989557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F0BCCDE3-4A65-F31F-CF78-4F20D3CACD0E}"/>
              </a:ext>
            </a:extLst>
          </p:cNvPr>
          <p:cNvSpPr txBox="1"/>
          <p:nvPr/>
        </p:nvSpPr>
        <p:spPr>
          <a:xfrm>
            <a:off x="323812" y="4693537"/>
            <a:ext cx="5524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72766" y="4617152"/>
            <a:ext cx="2430912" cy="208172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16094" y="6850355"/>
            <a:ext cx="2746602" cy="1798987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9289" y="4517201"/>
            <a:ext cx="3240026" cy="2029533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2"/>
          <a:srcRect l="37232" t="95121" r="48346"/>
          <a:stretch/>
        </p:blipFill>
        <p:spPr>
          <a:xfrm>
            <a:off x="8675806" y="8035613"/>
            <a:ext cx="698500" cy="157971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F0BCCDE3-4A65-F31F-CF78-4F20D3CACD0E}"/>
              </a:ext>
            </a:extLst>
          </p:cNvPr>
          <p:cNvSpPr txBox="1"/>
          <p:nvPr/>
        </p:nvSpPr>
        <p:spPr>
          <a:xfrm>
            <a:off x="7389897" y="4693537"/>
            <a:ext cx="5524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2"/>
          <a:srcRect l="75779" t="4904" b="35866"/>
          <a:stretch/>
        </p:blipFill>
        <p:spPr>
          <a:xfrm>
            <a:off x="9449161" y="5310932"/>
            <a:ext cx="1173044" cy="1917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33433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8E4383-CD85-3089-F2BA-5400FF330F30}"/>
              </a:ext>
            </a:extLst>
          </p:cNvPr>
          <p:cNvSpPr txBox="1"/>
          <p:nvPr/>
        </p:nvSpPr>
        <p:spPr>
          <a:xfrm>
            <a:off x="88309" y="8711529"/>
            <a:ext cx="5943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80EBA46-D47F-31C2-B3DF-A08C46526454}"/>
              </a:ext>
            </a:extLst>
          </p:cNvPr>
          <p:cNvSpPr txBox="1"/>
          <p:nvPr/>
        </p:nvSpPr>
        <p:spPr>
          <a:xfrm>
            <a:off x="196983" y="4677636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7FC030-6F1A-9344-15B9-FCA50B980A57}"/>
              </a:ext>
            </a:extLst>
          </p:cNvPr>
          <p:cNvSpPr txBox="1"/>
          <p:nvPr/>
        </p:nvSpPr>
        <p:spPr>
          <a:xfrm>
            <a:off x="5734803" y="4837970"/>
            <a:ext cx="126387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959A27E-B100-A606-0AEB-353CBA1E8162}"/>
              </a:ext>
            </a:extLst>
          </p:cNvPr>
          <p:cNvSpPr/>
          <p:nvPr/>
        </p:nvSpPr>
        <p:spPr>
          <a:xfrm>
            <a:off x="6184994" y="4409398"/>
            <a:ext cx="144363" cy="5935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" name="Group 4"/>
          <p:cNvGrpSpPr/>
          <p:nvPr/>
        </p:nvGrpSpPr>
        <p:grpSpPr>
          <a:xfrm>
            <a:off x="835948" y="4922154"/>
            <a:ext cx="3934666" cy="3869992"/>
            <a:chOff x="766689" y="4408925"/>
            <a:chExt cx="3934666" cy="3869992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D26AFD6-D51C-4333-BF13-679BCF1B7005}"/>
                </a:ext>
              </a:extLst>
            </p:cNvPr>
            <p:cNvGrpSpPr/>
            <p:nvPr/>
          </p:nvGrpSpPr>
          <p:grpSpPr>
            <a:xfrm>
              <a:off x="961144" y="7689651"/>
              <a:ext cx="3740211" cy="589266"/>
              <a:chOff x="1370686" y="5306341"/>
              <a:chExt cx="2799083" cy="569395"/>
            </a:xfrm>
          </p:grpSpPr>
          <p:pic>
            <p:nvPicPr>
              <p:cNvPr id="11" name="Picture 10" descr="A screenshot of a computer screen&#10;&#10;Description automatically generated">
                <a:extLst>
                  <a:ext uri="{FF2B5EF4-FFF2-40B4-BE49-F238E27FC236}">
                    <a16:creationId xmlns:a16="http://schemas.microsoft.com/office/drawing/2014/main" id="{75F3A956-08E1-4075-A9F7-E0D778AE88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6089" t="361" r="61746" b="93801"/>
              <a:stretch/>
            </p:blipFill>
            <p:spPr>
              <a:xfrm>
                <a:off x="1370686" y="5341838"/>
                <a:ext cx="132733" cy="176978"/>
              </a:xfrm>
              <a:prstGeom prst="rect">
                <a:avLst/>
              </a:prstGeom>
            </p:spPr>
          </p:pic>
          <p:pic>
            <p:nvPicPr>
              <p:cNvPr id="12" name="Picture 11" descr="A screenshot of a computer screen&#10;&#10;Description automatically generated">
                <a:extLst>
                  <a:ext uri="{FF2B5EF4-FFF2-40B4-BE49-F238E27FC236}">
                    <a16:creationId xmlns:a16="http://schemas.microsoft.com/office/drawing/2014/main" id="{0251C554-0DA3-4CE9-8FC0-68816F22F6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1833" t="798" r="46502" b="90430"/>
              <a:stretch/>
            </p:blipFill>
            <p:spPr>
              <a:xfrm>
                <a:off x="3175160" y="5351106"/>
                <a:ext cx="106863" cy="269972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9AE199C-CC1D-4BE9-B045-A4A37CF5D6D1}"/>
                  </a:ext>
                </a:extLst>
              </p:cNvPr>
              <p:cNvSpPr txBox="1"/>
              <p:nvPr/>
            </p:nvSpPr>
            <p:spPr>
              <a:xfrm>
                <a:off x="1433419" y="5310681"/>
                <a:ext cx="1670330" cy="565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ronic phase MPN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8435441-9105-41E8-9A8E-E38D3B808A91}"/>
                  </a:ext>
                </a:extLst>
              </p:cNvPr>
              <p:cNvSpPr txBox="1"/>
              <p:nvPr/>
            </p:nvSpPr>
            <p:spPr>
              <a:xfrm>
                <a:off x="3232655" y="5306341"/>
                <a:ext cx="937114" cy="565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e-</a:t>
                </a:r>
                <a:r>
                  <a:rPr lang="en-US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AML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D5410752-FA3C-4197-A7AE-4B752E89928F}"/>
                </a:ext>
              </a:extLst>
            </p:cNvPr>
            <p:cNvGrpSpPr/>
            <p:nvPr/>
          </p:nvGrpSpPr>
          <p:grpSpPr>
            <a:xfrm>
              <a:off x="766689" y="4408925"/>
              <a:ext cx="3843517" cy="3430216"/>
              <a:chOff x="-47755" y="4586516"/>
              <a:chExt cx="4941233" cy="3313160"/>
            </a:xfrm>
          </p:grpSpPr>
          <p:pic>
            <p:nvPicPr>
              <p:cNvPr id="19" name="Picture 18" descr="A screenshot of a computer screen&#10;&#10;Description automatically generated">
                <a:extLst>
                  <a:ext uri="{FF2B5EF4-FFF2-40B4-BE49-F238E27FC236}">
                    <a16:creationId xmlns:a16="http://schemas.microsoft.com/office/drawing/2014/main" id="{35379E84-EBCF-4C6B-ADF9-9A74B377A3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8636" r="28387" b="-3282"/>
              <a:stretch/>
            </p:blipFill>
            <p:spPr>
              <a:xfrm>
                <a:off x="-47755" y="4682995"/>
                <a:ext cx="4941233" cy="3216681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E2CC7FC-BE99-4F34-B43E-37F2C3A6F608}"/>
                  </a:ext>
                </a:extLst>
              </p:cNvPr>
              <p:cNvSpPr txBox="1"/>
              <p:nvPr/>
            </p:nvSpPr>
            <p:spPr>
              <a:xfrm>
                <a:off x="694382" y="4614999"/>
                <a:ext cx="9347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IT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D078824-1B81-4661-AC76-D4EDD36D075F}"/>
                  </a:ext>
                </a:extLst>
              </p:cNvPr>
              <p:cNvSpPr txBox="1"/>
              <p:nvPr/>
            </p:nvSpPr>
            <p:spPr>
              <a:xfrm>
                <a:off x="2244613" y="4614999"/>
                <a:ext cx="9347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IT3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A0DF9CF-E529-49E4-9D32-7EBAFF73C1C2}"/>
                  </a:ext>
                </a:extLst>
              </p:cNvPr>
              <p:cNvSpPr txBox="1"/>
              <p:nvPr/>
            </p:nvSpPr>
            <p:spPr>
              <a:xfrm>
                <a:off x="3552321" y="4586516"/>
                <a:ext cx="124157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G15</a:t>
                </a:r>
              </a:p>
            </p:txBody>
          </p:sp>
        </p:grp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00" t="11747" b="34793"/>
          <a:stretch/>
        </p:blipFill>
        <p:spPr>
          <a:xfrm>
            <a:off x="6505203" y="239064"/>
            <a:ext cx="5173199" cy="3284721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80EBA46-D47F-31C2-B3DF-A08C46526454}"/>
              </a:ext>
            </a:extLst>
          </p:cNvPr>
          <p:cNvSpPr txBox="1"/>
          <p:nvPr/>
        </p:nvSpPr>
        <p:spPr>
          <a:xfrm>
            <a:off x="5734803" y="97473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5483655" y="1557722"/>
            <a:ext cx="188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γ (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25" name="TextBox 24"/>
          <p:cNvSpPr txBox="1"/>
          <p:nvPr/>
        </p:nvSpPr>
        <p:spPr>
          <a:xfrm rot="19494657">
            <a:off x="6389757" y="3608633"/>
            <a:ext cx="19331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ealthy CD3+CD45+</a:t>
            </a:r>
          </a:p>
        </p:txBody>
      </p:sp>
      <p:sp>
        <p:nvSpPr>
          <p:cNvPr id="26" name="TextBox 25"/>
          <p:cNvSpPr txBox="1"/>
          <p:nvPr/>
        </p:nvSpPr>
        <p:spPr>
          <a:xfrm rot="19494657">
            <a:off x="7179172" y="3790713"/>
            <a:ext cx="19331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ealthy CD3-CD45+</a:t>
            </a:r>
          </a:p>
        </p:txBody>
      </p:sp>
      <p:sp>
        <p:nvSpPr>
          <p:cNvPr id="28" name="TextBox 27"/>
          <p:cNvSpPr txBox="1"/>
          <p:nvPr/>
        </p:nvSpPr>
        <p:spPr>
          <a:xfrm rot="19494657">
            <a:off x="8037314" y="3723713"/>
            <a:ext cx="19331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MT CD3+CD45+</a:t>
            </a:r>
          </a:p>
        </p:txBody>
      </p:sp>
      <p:sp>
        <p:nvSpPr>
          <p:cNvPr id="29" name="TextBox 28"/>
          <p:cNvSpPr txBox="1"/>
          <p:nvPr/>
        </p:nvSpPr>
        <p:spPr>
          <a:xfrm rot="19489150">
            <a:off x="8895923" y="3856744"/>
            <a:ext cx="19331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MT CD3-CD45+</a:t>
            </a:r>
          </a:p>
        </p:txBody>
      </p:sp>
      <p:sp>
        <p:nvSpPr>
          <p:cNvPr id="30" name="TextBox 29"/>
          <p:cNvSpPr txBox="1"/>
          <p:nvPr/>
        </p:nvSpPr>
        <p:spPr>
          <a:xfrm rot="19275273">
            <a:off x="9990258" y="3748003"/>
            <a:ext cx="1482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MT blas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5706" y="10907"/>
            <a:ext cx="3309471" cy="4776169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980EBA46-D47F-31C2-B3DF-A08C46526454}"/>
              </a:ext>
            </a:extLst>
          </p:cNvPr>
          <p:cNvSpPr txBox="1"/>
          <p:nvPr/>
        </p:nvSpPr>
        <p:spPr>
          <a:xfrm>
            <a:off x="198092" y="97473"/>
            <a:ext cx="17485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145B66BC-BD80-F5FC-AD7D-3EAF84FF5D1C}"/>
              </a:ext>
            </a:extLst>
          </p:cNvPr>
          <p:cNvGrpSpPr/>
          <p:nvPr/>
        </p:nvGrpSpPr>
        <p:grpSpPr>
          <a:xfrm>
            <a:off x="6084975" y="5192098"/>
            <a:ext cx="5593428" cy="3519431"/>
            <a:chOff x="6084975" y="5192098"/>
            <a:chExt cx="5593428" cy="3519431"/>
          </a:xfrm>
        </p:grpSpPr>
        <p:pic>
          <p:nvPicPr>
            <p:cNvPr id="16" name="Picture 15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E3866B1A-C0E9-C6B1-6A58-C69E48AAE36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15735" y="5299245"/>
              <a:ext cx="5562668" cy="3412284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D3C2270-7D9C-B415-10F3-1BC559B6A561}"/>
                </a:ext>
              </a:extLst>
            </p:cNvPr>
            <p:cNvSpPr/>
            <p:nvPr/>
          </p:nvSpPr>
          <p:spPr>
            <a:xfrm>
              <a:off x="6084975" y="5192098"/>
              <a:ext cx="402588" cy="3092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28066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060</TotalTime>
  <Words>226</Words>
  <Application>Microsoft Macintosh PowerPoint</Application>
  <PresentationFormat>Custom</PresentationFormat>
  <Paragraphs>11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odoros Karantanos</dc:creator>
  <cp:lastModifiedBy>Nour Naji</cp:lastModifiedBy>
  <cp:revision>733</cp:revision>
  <dcterms:created xsi:type="dcterms:W3CDTF">2023-10-14T02:14:04Z</dcterms:created>
  <dcterms:modified xsi:type="dcterms:W3CDTF">2025-02-21T17:09:34Z</dcterms:modified>
</cp:coreProperties>
</file>